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3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F80C18-9CC4-4C0E-922F-59E2074B201A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3B59CA-24CF-42AD-9FA0-A462F70FA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4231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926104">
              <a:defRPr/>
            </a:pPr>
            <a:fld id="{5A1879EE-FA31-4829-8AB7-38EFBF31CEE4}" type="slidenum">
              <a:rPr lang="en-US" sz="1800" kern="0">
                <a:solidFill>
                  <a:sysClr val="windowText" lastClr="000000"/>
                </a:solidFill>
              </a:rPr>
              <a:pPr defTabSz="926104">
                <a:defRPr/>
              </a:pPr>
              <a:t>1</a:t>
            </a:fld>
            <a:endParaRPr lang="en-US" sz="1800" kern="0">
              <a:solidFill>
                <a:sysClr val="windowText" lastClr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8178504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27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27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3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45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157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1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2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1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30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463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84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82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hyperlink" Target="#_ENREF_127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80605" y="4088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80605" y="126776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0605" y="391400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0605" y="21614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0605" y="5486400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80605" y="464820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15051" name="Picture 1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962400"/>
            <a:ext cx="5220000" cy="56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5054" name="Picture 1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4572000"/>
            <a:ext cx="5238000" cy="75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15055" name="Picture 1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5410200"/>
            <a:ext cx="5214000" cy="75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4898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8376" y="483600"/>
            <a:ext cx="5550000" cy="88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4899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8376" y="3200400"/>
            <a:ext cx="5736000" cy="86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4900" name="Picture 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8376" y="1339200"/>
            <a:ext cx="5742000" cy="95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380605" y="30758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8376" y="2260800"/>
            <a:ext cx="5562000" cy="97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Rectangle 15"/>
          <p:cNvSpPr/>
          <p:nvPr/>
        </p:nvSpPr>
        <p:spPr>
          <a:xfrm>
            <a:off x="609600" y="6253899"/>
            <a:ext cx="5562600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5 Fig  EcoHIV and MLV genom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genome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coHI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NDK (A)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-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variants in) are derived from the molecular clone HIV-1/NDK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hlinkClick r:id="rId10" action="ppaction://hlinkfile" tooltip="Ellrodt, 1984 #839"/>
              </a:rPr>
              <a:t>4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in which the HIV genes are shown in blue and the MLV gp80 was shown in red and black (deletion).  The internal ribosome entry site (IRES) shown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ermits expression of EGFP and luciferase from the HIV RNA transcript.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constructed by introducing two stop codes followed ATG of the coding region of signal peptide based o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-G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genome of MLV variants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derived from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y introducing two stop codes followed ATG of the coding region of signal peptide in gp80.  2A peptide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derived from porcine teschovirus-1.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90334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63</Words>
  <Application>Microsoft Office PowerPoint</Application>
  <PresentationFormat>Letter Paper (8.5x11 in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Volsky</dc:creator>
  <cp:lastModifiedBy>David Volsky</cp:lastModifiedBy>
  <cp:revision>8</cp:revision>
  <dcterms:created xsi:type="dcterms:W3CDTF">2018-05-11T18:35:20Z</dcterms:created>
  <dcterms:modified xsi:type="dcterms:W3CDTF">2018-05-14T19:26:46Z</dcterms:modified>
</cp:coreProperties>
</file>